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709"/>
  </p:normalViewPr>
  <p:slideViewPr>
    <p:cSldViewPr showGuides="1">
      <p:cViewPr varScale="1">
        <p:scale>
          <a:sx n="92" d="100"/>
          <a:sy n="92" d="100"/>
        </p:scale>
        <p:origin x="166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Υπότιτλος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/>
              <a:t>Στυλ κύριου υπότιτλ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647D3-26BA-4CAA-A2CC-F7030CB48ACE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35EA-073C-4C72-BACF-5AE4BF78DA5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1938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647D3-26BA-4CAA-A2CC-F7030CB48ACE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35EA-073C-4C72-BACF-5AE4BF78DA5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84003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647D3-26BA-4CAA-A2CC-F7030CB48ACE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35EA-073C-4C72-BACF-5AE4BF78DA5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45582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647D3-26BA-4CAA-A2CC-F7030CB48ACE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35EA-073C-4C72-BACF-5AE4BF78DA5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5004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647D3-26BA-4CAA-A2CC-F7030CB48ACE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35EA-073C-4C72-BACF-5AE4BF78DA5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20546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647D3-26BA-4CAA-A2CC-F7030CB48ACE}" type="datetimeFigureOut">
              <a:rPr lang="el-GR" smtClean="0"/>
              <a:t>29/4/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35EA-073C-4C72-BACF-5AE4BF78DA5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32651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Θέση κειμένου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6" name="Θέση περιεχομένου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7" name="Θέση ημερομηνίας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647D3-26BA-4CAA-A2CC-F7030CB48ACE}" type="datetimeFigureOut">
              <a:rPr lang="el-GR" smtClean="0"/>
              <a:t>29/4/21</a:t>
            </a:fld>
            <a:endParaRPr lang="el-GR"/>
          </a:p>
        </p:txBody>
      </p:sp>
      <p:sp>
        <p:nvSpPr>
          <p:cNvPr id="8" name="Θέση υποσέλιδου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35EA-073C-4C72-BACF-5AE4BF78DA5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530100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647D3-26BA-4CAA-A2CC-F7030CB48ACE}" type="datetimeFigureOut">
              <a:rPr lang="el-GR" smtClean="0"/>
              <a:t>29/4/21</a:t>
            </a:fld>
            <a:endParaRPr lang="el-GR"/>
          </a:p>
        </p:txBody>
      </p:sp>
      <p:sp>
        <p:nvSpPr>
          <p:cNvPr id="4" name="Θέση υποσέλιδου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35EA-073C-4C72-BACF-5AE4BF78DA5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78996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647D3-26BA-4CAA-A2CC-F7030CB48ACE}" type="datetimeFigureOut">
              <a:rPr lang="el-GR" smtClean="0"/>
              <a:t>29/4/21</a:t>
            </a:fld>
            <a:endParaRPr lang="el-GR"/>
          </a:p>
        </p:txBody>
      </p:sp>
      <p:sp>
        <p:nvSpPr>
          <p:cNvPr id="3" name="Θέση υποσέλιδου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35EA-073C-4C72-BACF-5AE4BF78DA5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730115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647D3-26BA-4CAA-A2CC-F7030CB48ACE}" type="datetimeFigureOut">
              <a:rPr lang="el-GR" smtClean="0"/>
              <a:t>29/4/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35EA-073C-4C72-BACF-5AE4BF78DA5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72328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εικόνας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647D3-26BA-4CAA-A2CC-F7030CB48ACE}" type="datetimeFigureOut">
              <a:rPr lang="el-GR" smtClean="0"/>
              <a:t>29/4/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335EA-073C-4C72-BACF-5AE4BF78DA5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6561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7647D3-26BA-4CAA-A2CC-F7030CB48ACE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335EA-073C-4C72-BACF-5AE4BF78DA5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22800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Εικόνα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8000" y="576000"/>
            <a:ext cx="5669280" cy="544639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61782" y="6157901"/>
            <a:ext cx="863069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ure S4. </a:t>
            </a:r>
            <a:r>
              <a:rPr lang="en-US" dirty="0"/>
              <a:t>BRIG comparison of </a:t>
            </a:r>
            <a:r>
              <a:rPr lang="en-US" dirty="0" err="1"/>
              <a:t>IncN</a:t>
            </a:r>
            <a:r>
              <a:rPr lang="en-US" dirty="0"/>
              <a:t> KPC-encoding plasmids characterized from </a:t>
            </a:r>
            <a:r>
              <a:rPr lang="en-US" i="1" dirty="0" err="1"/>
              <a:t>Enterobacterales</a:t>
            </a:r>
            <a:r>
              <a:rPr lang="en-US" dirty="0"/>
              <a:t> isolates recovered from Czech hospitals.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1042743547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8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Θέμα του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biochem1</dc:creator>
  <cp:lastModifiedBy>ibrahim bitar</cp:lastModifiedBy>
  <cp:revision>4</cp:revision>
  <dcterms:created xsi:type="dcterms:W3CDTF">2021-03-26T12:21:29Z</dcterms:created>
  <dcterms:modified xsi:type="dcterms:W3CDTF">2021-04-29T08:20:17Z</dcterms:modified>
</cp:coreProperties>
</file>